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59" r:id="rId3"/>
    <p:sldId id="260" r:id="rId4"/>
    <p:sldId id="261" r:id="rId5"/>
    <p:sldId id="26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178" y="-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442CCB-3EC0-4B05-9A92-02562B5FAE37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03F49-CB28-436A-8EF9-2F1CEA81B18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3175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Senior</a:t>
            </a:r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603F49-CB28-436A-8EF9-2F1CEA81B18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31083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Junior</a:t>
            </a:r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603F49-CB28-436A-8EF9-2F1CEA81B186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0633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237BDA-C604-4778-AB49-129E537337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2458607-CC45-4AEA-A597-5B2838EE93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8A85489-A02F-450C-8757-F3CBBFBE0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AA0FAC3-EA79-45FA-AE71-B1F2FA42D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DB644A7-9E3F-4AF6-9F4C-0D3811E50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54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E612458-6003-4C7C-91E9-48B01E7AFE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850C5FD-E41E-44E9-AACF-CF5A5D011A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9EA9285-64CF-4B7A-BDBE-A335141D4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09F55F3-6FFB-4E52-BD08-93CBE7CCC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C9320C-BF12-48AC-ACB4-C8EBB4807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416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FE00C1C-BA78-4F68-B7A5-FBC1E3ECDC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12C8ADC-425C-4D24-8DCF-E648138B58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B270FD-7180-4AE7-B7F4-4306D7DDC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96E3E1D-7A87-48E2-8946-AC0FD3C98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CACEB06-2818-47EB-B2EF-8E7BCA0F0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582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85DB005-9412-42ED-A2E7-E78832689C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17E8A4F-4122-4750-A461-0395E9C861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4AA98DB-5947-4880-81E9-BF067F3AB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2CED1D-C5E6-4AD6-B024-0ED9B55C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411CE81-DEAD-43D4-B9EB-F5152BE49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949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C8C225-C281-44D2-A14F-46080C439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89094D0-AB71-42B7-908C-3ED62446EE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722DDC2-AE4A-4359-8D45-16E897E02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5AC43F-3EB5-41E5-B130-5855BFBE7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220B03-23B9-4F7C-86E2-D787C85BE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8428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1E76705-8CAC-426F-A651-E213164ABD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906626D-D9ED-46CA-9BD0-3BAF135BC8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DE80290-A3B0-4FDA-BAC6-BA0C2467DF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BAA845A-E38A-4269-AB2F-E60DF3BEE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9E1806F-4EDA-4AED-A8DB-86C87D5BB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3CE845E-79B6-499C-BEE7-AC046B0B9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9678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01C4E6-6225-4F82-9080-BF2B85317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8C0FB55-5E02-4B7A-B026-8860FC9C7D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B29FFE6-D39B-4102-A0D8-455D7B7CBB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B947742-E8CB-4F99-8631-716214286D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6F64416-3FA3-44B6-B7BB-03934D214B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B160258-37A6-41CB-803D-AF3E39FE3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15D0F2A-92A4-40E0-9C64-E98A4E830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635A410-31EE-44EF-A6C8-E90EAF80B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2994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E4AB50-FE4A-43C3-AD79-00DDBE9FC7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471FF48-099F-4AB4-889E-72F37F43C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AF8EBCE-7030-4FB8-B44F-1009ED9C9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047ED2A-0B82-4E54-881A-9928FBAE5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140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E330C04-0F41-4DF1-91F0-DE7BF7916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09B243D-812B-40CF-AB20-90F4FF8EF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42A2078-A4A0-4091-83BA-E4DFBBA3C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5529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9E7B6D-7D16-445C-9BC0-511B65525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EB4BEDA-DB03-4F4E-8021-D3D6782C2B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0875347-6467-4CE5-A439-D46B755B17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A7CA447-AC3F-4176-A78E-2D5D6A2B9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D692C05-E926-4642-9086-1CF8B722F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ADF1C49-D007-4E2B-AFAF-1EBCFCCBA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0686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15F59DF-5948-4280-AB10-FC3E22CDA6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CC9A9A2-1A2B-47AE-BFE1-7343018214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4F8A867-277B-479C-B0BD-11B6B4ABEE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3D36717-9310-4FC8-94FD-0E29443E0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16076D4-3FF9-40EE-84D6-79712AAB8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1BEDD3F-A516-4797-A714-F2DDA0219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876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3ACA900-FC82-490B-B6FA-2CA95545E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69B7A48-80A0-4849-9BBA-65119C6D2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42ACBF6-EBA0-4FA0-B2B8-743490A045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E41B6-367F-41C8-B04E-3FAF931A232B}" type="datetimeFigureOut">
              <a:rPr lang="en-GB" smtClean="0"/>
              <a:t>20/01/2023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DBE6D3-78D4-4D9A-86B3-4C41C40110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99C7921-EF19-4F5A-B6A8-A74A5039DC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E39A2-4F9E-4234-98BC-F31860677F3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5688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png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>
            <a:extLst>
              <a:ext uri="{FF2B5EF4-FFF2-40B4-BE49-F238E27FC236}">
                <a16:creationId xmlns:a16="http://schemas.microsoft.com/office/drawing/2014/main" id="{540A6DD3-94F8-AEB0-74ED-7B4164C125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1028" name="Immagine 2">
            <a:extLst>
              <a:ext uri="{FF2B5EF4-FFF2-40B4-BE49-F238E27FC236}">
                <a16:creationId xmlns:a16="http://schemas.microsoft.com/office/drawing/2014/main" id="{EF4A622A-600A-4A69-671A-BC57F4190A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9600" y="0"/>
            <a:ext cx="8152941" cy="61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6">
            <a:extLst>
              <a:ext uri="{FF2B5EF4-FFF2-40B4-BE49-F238E27FC236}">
                <a16:creationId xmlns:a16="http://schemas.microsoft.com/office/drawing/2014/main" id="{2FC86BFD-C46B-44D9-A52C-129AB814AA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269058"/>
            <a:ext cx="12192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SC of MD and MD&amp;MV subgroup respect to the slice thicknesses (i.e., ≤ 3 mm and &gt; 3 mm, indicated as 0 and 1, respectively). The statistical significance was assessed using the Wilcoxon test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62930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09989A6A-AC5A-BC1E-7246-F74B173C6E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2049" name="Immagine 1">
            <a:extLst>
              <a:ext uri="{FF2B5EF4-FFF2-40B4-BE49-F238E27FC236}">
                <a16:creationId xmlns:a16="http://schemas.microsoft.com/office/drawing/2014/main" id="{9750180F-6AB9-62E0-FC62-4CF8BCFD68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9121" y="0"/>
            <a:ext cx="8152941" cy="61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3">
            <a:extLst>
              <a:ext uri="{FF2B5EF4-FFF2-40B4-BE49-F238E27FC236}">
                <a16:creationId xmlns:a16="http://schemas.microsoft.com/office/drawing/2014/main" id="{1590CA15-780F-5CE2-C313-FA053FB7AC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8580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SC of MD and MD&amp;MV subgroup respect to the CT scanner used for image acquisition. The statistical significance was assessed using the Wilcoxon test.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kumimoji="0" lang="en-GB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43553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D3F310CC-6FDC-6513-D7E1-7464E7A2A9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3073" name="Immagine 4">
            <a:extLst>
              <a:ext uri="{FF2B5EF4-FFF2-40B4-BE49-F238E27FC236}">
                <a16:creationId xmlns:a16="http://schemas.microsoft.com/office/drawing/2014/main" id="{9A88D104-573F-BB46-F979-ABC4B0F51C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9745" y="67459"/>
            <a:ext cx="8167070" cy="61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463DCA18-BC36-D0B0-30B2-23B38540EF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-81280" y="6328876"/>
            <a:ext cx="1170432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SC of MD and MD&amp;MV subgroup respect to the absence or presence of contrast medium (indicated as CM: no and CM: yes, respectively) in the investigated images. The statistical significance was assessed using the Wilcoxon test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48360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3874D110-32F5-177E-F9EF-33BECC2F0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4097" name="Immagine 17">
            <a:extLst>
              <a:ext uri="{FF2B5EF4-FFF2-40B4-BE49-F238E27FC236}">
                <a16:creationId xmlns:a16="http://schemas.microsoft.com/office/drawing/2014/main" id="{30DF3FE4-4410-AF83-F0D0-CAA1317176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2805" y="0"/>
            <a:ext cx="6759350" cy="61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9A6C4900-416B-E64D-CFAF-B5D4208B1A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145010"/>
            <a:ext cx="11919098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ercentage number of cases for S subgroup in which the (A) DSC coefficients of the manually delineated VOIs (MD) or manually modified from auto-segmented VOIs (MD&amp;MV) were higher than 0.8 when compared to MV alone, (B) MDA coefficients were lower than 3 mm for the same groups. The count (%) is calculated with regards to the total number of patients in the considered subgroup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51482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o 18">
            <a:extLst>
              <a:ext uri="{FF2B5EF4-FFF2-40B4-BE49-F238E27FC236}">
                <a16:creationId xmlns:a16="http://schemas.microsoft.com/office/drawing/2014/main" id="{005BC07A-8C90-2F26-4886-818AA759BC22}"/>
              </a:ext>
            </a:extLst>
          </p:cNvPr>
          <p:cNvGrpSpPr/>
          <p:nvPr/>
        </p:nvGrpSpPr>
        <p:grpSpPr>
          <a:xfrm>
            <a:off x="2416745" y="0"/>
            <a:ext cx="6761022" cy="6120000"/>
            <a:chOff x="2416745" y="0"/>
            <a:chExt cx="7358753" cy="6638831"/>
          </a:xfrm>
        </p:grpSpPr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F00A46B9-D2E7-B128-FC44-5BCA272E33CD}"/>
                </a:ext>
              </a:extLst>
            </p:cNvPr>
            <p:cNvGrpSpPr/>
            <p:nvPr/>
          </p:nvGrpSpPr>
          <p:grpSpPr>
            <a:xfrm>
              <a:off x="2416745" y="0"/>
              <a:ext cx="7358510" cy="6620830"/>
              <a:chOff x="2416745" y="0"/>
              <a:chExt cx="7358510" cy="6620830"/>
            </a:xfrm>
          </p:grpSpPr>
          <p:grpSp>
            <p:nvGrpSpPr>
              <p:cNvPr id="4" name="Gruppo 3">
                <a:extLst>
                  <a:ext uri="{FF2B5EF4-FFF2-40B4-BE49-F238E27FC236}">
                    <a16:creationId xmlns:a16="http://schemas.microsoft.com/office/drawing/2014/main" id="{DB1996A6-24DF-2B7C-D56C-BFBE3E639018}"/>
                  </a:ext>
                </a:extLst>
              </p:cNvPr>
              <p:cNvGrpSpPr/>
              <p:nvPr/>
            </p:nvGrpSpPr>
            <p:grpSpPr>
              <a:xfrm>
                <a:off x="2416745" y="0"/>
                <a:ext cx="7358510" cy="6620830"/>
                <a:chOff x="2416745" y="0"/>
                <a:chExt cx="7358510" cy="6620830"/>
              </a:xfrm>
            </p:grpSpPr>
            <p:pic>
              <p:nvPicPr>
                <p:cNvPr id="11" name="Immagine 10">
                  <a:extLst>
                    <a:ext uri="{FF2B5EF4-FFF2-40B4-BE49-F238E27FC236}">
                      <a16:creationId xmlns:a16="http://schemas.microsoft.com/office/drawing/2014/main" id="{8AA56202-DBAF-4BBD-BF54-C0544E0F99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416745" y="0"/>
                  <a:ext cx="7358510" cy="6620830"/>
                </a:xfrm>
                <a:prstGeom prst="rect">
                  <a:avLst/>
                </a:prstGeom>
              </p:spPr>
            </p:pic>
            <p:sp>
              <p:nvSpPr>
                <p:cNvPr id="2" name="CasellaDiTesto 1">
                  <a:extLst>
                    <a:ext uri="{FF2B5EF4-FFF2-40B4-BE49-F238E27FC236}">
                      <a16:creationId xmlns:a16="http://schemas.microsoft.com/office/drawing/2014/main" id="{AEFD7489-629B-0198-7EFE-DC116B5FEAAC}"/>
                    </a:ext>
                  </a:extLst>
                </p:cNvPr>
                <p:cNvSpPr txBox="1"/>
                <p:nvPr/>
              </p:nvSpPr>
              <p:spPr>
                <a:xfrm>
                  <a:off x="2490194" y="18001"/>
                  <a:ext cx="428322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it-IT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)</a:t>
                  </a:r>
                  <a:endPara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" name="CasellaDiTesto 2">
                  <a:extLst>
                    <a:ext uri="{FF2B5EF4-FFF2-40B4-BE49-F238E27FC236}">
                      <a16:creationId xmlns:a16="http://schemas.microsoft.com/office/drawing/2014/main" id="{F7F10581-5F7C-81BC-07F0-3CA00A357AD5}"/>
                    </a:ext>
                  </a:extLst>
                </p:cNvPr>
                <p:cNvSpPr txBox="1"/>
                <p:nvPr/>
              </p:nvSpPr>
              <p:spPr>
                <a:xfrm>
                  <a:off x="2496000" y="3438001"/>
                  <a:ext cx="415498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it-IT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)</a:t>
                  </a:r>
                  <a:endParaRPr lang="en-GB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8" name="Immagine 7">
                <a:extLst>
                  <a:ext uri="{FF2B5EF4-FFF2-40B4-BE49-F238E27FC236}">
                    <a16:creationId xmlns:a16="http://schemas.microsoft.com/office/drawing/2014/main" id="{5AB9F74A-14E1-EEBF-D6BE-E72A8837C7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036270" y="2601310"/>
                <a:ext cx="303798" cy="71482"/>
              </a:xfrm>
              <a:prstGeom prst="rect">
                <a:avLst/>
              </a:prstGeom>
            </p:spPr>
          </p:pic>
          <p:sp>
            <p:nvSpPr>
              <p:cNvPr id="9" name="Rettangolo 8">
                <a:extLst>
                  <a:ext uri="{FF2B5EF4-FFF2-40B4-BE49-F238E27FC236}">
                    <a16:creationId xmlns:a16="http://schemas.microsoft.com/office/drawing/2014/main" id="{72D8CD91-AF9A-0579-FBBB-299625D6A281}"/>
                  </a:ext>
                </a:extLst>
              </p:cNvPr>
              <p:cNvSpPr/>
              <p:nvPr/>
            </p:nvSpPr>
            <p:spPr>
              <a:xfrm>
                <a:off x="2962698" y="2565061"/>
                <a:ext cx="73572" cy="128752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id="{9C5CC1F3-27D5-2E2A-0F0D-3434C2E06FC0}"/>
                </a:ext>
              </a:extLst>
            </p:cNvPr>
            <p:cNvGrpSpPr/>
            <p:nvPr/>
          </p:nvGrpSpPr>
          <p:grpSpPr>
            <a:xfrm>
              <a:off x="2842052" y="3370337"/>
              <a:ext cx="6933204" cy="3268494"/>
              <a:chOff x="0" y="198120"/>
              <a:chExt cx="12192000" cy="5689600"/>
            </a:xfrm>
          </p:grpSpPr>
          <p:pic>
            <p:nvPicPr>
              <p:cNvPr id="12" name="Immagine 11">
                <a:extLst>
                  <a:ext uri="{FF2B5EF4-FFF2-40B4-BE49-F238E27FC236}">
                    <a16:creationId xmlns:a16="http://schemas.microsoft.com/office/drawing/2014/main" id="{36005DE8-14BA-2C2B-839D-BE4D052428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198120"/>
                <a:ext cx="12192000" cy="5689600"/>
              </a:xfrm>
              <a:prstGeom prst="rect">
                <a:avLst/>
              </a:prstGeom>
            </p:spPr>
          </p:pic>
          <p:sp>
            <p:nvSpPr>
              <p:cNvPr id="13" name="Rettangolo 12">
                <a:extLst>
                  <a:ext uri="{FF2B5EF4-FFF2-40B4-BE49-F238E27FC236}">
                    <a16:creationId xmlns:a16="http://schemas.microsoft.com/office/drawing/2014/main" id="{0925176A-9A1A-294F-FA91-8EF9233AB793}"/>
                  </a:ext>
                </a:extLst>
              </p:cNvPr>
              <p:cNvSpPr/>
              <p:nvPr/>
            </p:nvSpPr>
            <p:spPr>
              <a:xfrm>
                <a:off x="244641" y="4720389"/>
                <a:ext cx="661737" cy="140367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14" name="Immagine 13">
                <a:extLst>
                  <a:ext uri="{FF2B5EF4-FFF2-40B4-BE49-F238E27FC236}">
                    <a16:creationId xmlns:a16="http://schemas.microsoft.com/office/drawing/2014/main" id="{90122E33-660F-BDBF-FCED-6B8A421705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01052" y="4720388"/>
                <a:ext cx="505326" cy="140368"/>
              </a:xfrm>
              <a:prstGeom prst="rect">
                <a:avLst/>
              </a:prstGeom>
            </p:spPr>
          </p:pic>
        </p:grpSp>
        <p:grpSp>
          <p:nvGrpSpPr>
            <p:cNvPr id="15" name="Gruppo 14">
              <a:extLst>
                <a:ext uri="{FF2B5EF4-FFF2-40B4-BE49-F238E27FC236}">
                  <a16:creationId xmlns:a16="http://schemas.microsoft.com/office/drawing/2014/main" id="{D9217C5F-2CAE-D537-D791-A5AA995432C4}"/>
                </a:ext>
              </a:extLst>
            </p:cNvPr>
            <p:cNvGrpSpPr/>
            <p:nvPr/>
          </p:nvGrpSpPr>
          <p:grpSpPr>
            <a:xfrm>
              <a:off x="2842294" y="18000"/>
              <a:ext cx="6933204" cy="3268494"/>
              <a:chOff x="4538407" y="326765"/>
              <a:chExt cx="12192000" cy="5689600"/>
            </a:xfrm>
          </p:grpSpPr>
          <p:pic>
            <p:nvPicPr>
              <p:cNvPr id="16" name="Immagine 15">
                <a:extLst>
                  <a:ext uri="{FF2B5EF4-FFF2-40B4-BE49-F238E27FC236}">
                    <a16:creationId xmlns:a16="http://schemas.microsoft.com/office/drawing/2014/main" id="{AE01EC8B-413B-D475-5494-9BEAFD753B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38407" y="326765"/>
                <a:ext cx="12192000" cy="5689600"/>
              </a:xfrm>
              <a:prstGeom prst="rect">
                <a:avLst/>
              </a:prstGeom>
            </p:spPr>
          </p:pic>
          <p:sp>
            <p:nvSpPr>
              <p:cNvPr id="17" name="Rettangolo 16">
                <a:extLst>
                  <a:ext uri="{FF2B5EF4-FFF2-40B4-BE49-F238E27FC236}">
                    <a16:creationId xmlns:a16="http://schemas.microsoft.com/office/drawing/2014/main" id="{F2A2C64C-7A75-4737-6814-9AFB72B0C40E}"/>
                  </a:ext>
                </a:extLst>
              </p:cNvPr>
              <p:cNvSpPr/>
              <p:nvPr/>
            </p:nvSpPr>
            <p:spPr>
              <a:xfrm>
                <a:off x="4762213" y="4860757"/>
                <a:ext cx="661737" cy="140367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18" name="Immagine 17">
                <a:extLst>
                  <a:ext uri="{FF2B5EF4-FFF2-40B4-BE49-F238E27FC236}">
                    <a16:creationId xmlns:a16="http://schemas.microsoft.com/office/drawing/2014/main" id="{38939375-4741-77D6-0604-FE46DA6993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918628" y="4849870"/>
                <a:ext cx="505322" cy="140367"/>
              </a:xfrm>
              <a:prstGeom prst="rect">
                <a:avLst/>
              </a:prstGeom>
            </p:spPr>
          </p:pic>
        </p:grpSp>
      </p:grpSp>
      <p:sp>
        <p:nvSpPr>
          <p:cNvPr id="6" name="Rectangle 3">
            <a:extLst>
              <a:ext uri="{FF2B5EF4-FFF2-40B4-BE49-F238E27FC236}">
                <a16:creationId xmlns:a16="http://schemas.microsoft.com/office/drawing/2014/main" id="{A298F60A-4A5D-E2F6-09A1-EC46F95ECD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145010"/>
            <a:ext cx="11919098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percentage number of cases for J subgroup in which the (A) DSC coefficients of the manually delineated VOIs (MD) or manually modified from auto-segmented VOIs (MD&amp;MV) were higher than 0.8 when compared to MV alone, (B) MDA coefficients were lower than 3 mm for the same groups. The count (%) is calculated with regards to the total number of patients in the considered subgroup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29172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7</TotalTime>
  <Words>297</Words>
  <Application>Microsoft Office PowerPoint</Application>
  <PresentationFormat>Widescreen</PresentationFormat>
  <Paragraphs>12</Paragraphs>
  <Slides>5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riam Santoro - miriam.santoro@studio.unibo.it</dc:creator>
  <cp:lastModifiedBy>Miriam Santoro - miriam.santoro@studio.unibo.it</cp:lastModifiedBy>
  <cp:revision>18</cp:revision>
  <dcterms:created xsi:type="dcterms:W3CDTF">2022-02-10T15:41:13Z</dcterms:created>
  <dcterms:modified xsi:type="dcterms:W3CDTF">2023-01-20T07:59:59Z</dcterms:modified>
</cp:coreProperties>
</file>